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3"/>
  </p:notesMasterIdLst>
  <p:sldIdLst>
    <p:sldId id="274" r:id="rId2"/>
  </p:sldIdLst>
  <p:sldSz cx="6858000" cy="9144000" type="screen4x3"/>
  <p:notesSz cx="6858000" cy="9144000"/>
  <p:defaultTextStyle>
    <a:defPPr>
      <a:defRPr lang="fr-FR"/>
    </a:defPPr>
    <a:lvl1pPr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8879" autoAdjust="0"/>
    <p:restoredTop sz="99701" autoAdjust="0"/>
  </p:normalViewPr>
  <p:slideViewPr>
    <p:cSldViewPr>
      <p:cViewPr>
        <p:scale>
          <a:sx n="100" d="100"/>
          <a:sy n="100" d="100"/>
        </p:scale>
        <p:origin x="-2160" y="123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file:///\\lipme\balague\Priv\projets\projet-Gaudin-LIF2\expressionCol-H2O-M1-DC3000.xlsx" TargetMode="External"/><Relationship Id="rId3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file:///\\lipme\balague\Priv\projets\projet-Gaudin-LIF2\expression\expressionCol-H2O-M1-DC3000.xlsx" TargetMode="External"/><Relationship Id="rId3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39965890505506"/>
          <c:y val="0.0560473052062419"/>
          <c:w val="0.754462588952104"/>
          <c:h val="0.762836689244393"/>
        </c:manualLayout>
      </c:layout>
      <c:scatterChart>
        <c:scatterStyle val="lineMarker"/>
        <c:varyColors val="0"/>
        <c:ser>
          <c:idx val="0"/>
          <c:order val="0"/>
          <c:tx>
            <c:strRef>
              <c:f>'expressionCol-H2O-M1-DC3000'!$M$2</c:f>
              <c:strCache>
                <c:ptCount val="1"/>
                <c:pt idx="0">
                  <c:v>H2O</c:v>
                </c:pt>
              </c:strCache>
            </c:strRef>
          </c:tx>
          <c:errBars>
            <c:errDir val="y"/>
            <c:errBarType val="plus"/>
            <c:errValType val="cust"/>
            <c:noEndCap val="0"/>
            <c:plus>
              <c:numRef>
                <c:f>('expressionCol-H2O-M1-DC3000'!$J$27,'expressionCol-H2O-M1-DC3000'!$J$6,'expressionCol-H2O-M1-DC3000'!$J$9,'expressionCol-H2O-M1-DC3000'!$J$12,'expressionCol-H2O-M1-DC3000'!$J$16,'expressionCol-H2O-M1-DC3000'!$J$20)</c:f>
                <c:numCache>
                  <c:formatCode>General</c:formatCode>
                  <c:ptCount val="6"/>
                  <c:pt idx="0">
                    <c:v>0.1172302247716</c:v>
                  </c:pt>
                  <c:pt idx="1">
                    <c:v>0.398827239123241</c:v>
                  </c:pt>
                  <c:pt idx="2">
                    <c:v>0.3786</c:v>
                  </c:pt>
                  <c:pt idx="3">
                    <c:v>0.222387549611534</c:v>
                  </c:pt>
                  <c:pt idx="4">
                    <c:v>0.0</c:v>
                  </c:pt>
                  <c:pt idx="5">
                    <c:v>0.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xVal>
            <c:numRef>
              <c:f>'expressionCol-H2O-M1-DC3000'!$L$3:$L$8</c:f>
              <c:numCache>
                <c:formatCode>General</c:formatCode>
                <c:ptCount val="6"/>
                <c:pt idx="0">
                  <c:v>0.0</c:v>
                </c:pt>
                <c:pt idx="1">
                  <c:v>4.0</c:v>
                </c:pt>
                <c:pt idx="2">
                  <c:v>8.0</c:v>
                </c:pt>
                <c:pt idx="3">
                  <c:v>12.0</c:v>
                </c:pt>
                <c:pt idx="4">
                  <c:v>24.0</c:v>
                </c:pt>
                <c:pt idx="5">
                  <c:v>48.0</c:v>
                </c:pt>
              </c:numCache>
            </c:numRef>
          </c:xVal>
          <c:yVal>
            <c:numRef>
              <c:f>'expressionCol-H2O-M1-DC3000'!$M$3:$M$8</c:f>
              <c:numCache>
                <c:formatCode>General</c:formatCode>
                <c:ptCount val="6"/>
                <c:pt idx="0">
                  <c:v>0.48358</c:v>
                </c:pt>
                <c:pt idx="1">
                  <c:v>1.069</c:v>
                </c:pt>
                <c:pt idx="2">
                  <c:v>1.218399999999999</c:v>
                </c:pt>
                <c:pt idx="3">
                  <c:v>1.391666666666667</c:v>
                </c:pt>
                <c:pt idx="4">
                  <c:v>1.415999999999999</c:v>
                </c:pt>
                <c:pt idx="5">
                  <c:v>1.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expressionCol-H2O-M1-DC3000'!$N$2</c:f>
              <c:strCache>
                <c:ptCount val="1"/>
                <c:pt idx="0">
                  <c:v>Rpm1</c:v>
                </c:pt>
              </c:strCache>
            </c:strRef>
          </c:tx>
          <c:errBars>
            <c:errDir val="y"/>
            <c:errBarType val="plus"/>
            <c:errValType val="cust"/>
            <c:noEndCap val="0"/>
            <c:plus>
              <c:numRef>
                <c:f>('expressionCol-H2O-M1-DC3000'!$J$27,'expressionCol-H2O-M1-DC3000'!$J$32,'expressionCol-H2O-M1-DC3000'!$J$35,'expressionCol-H2O-M1-DC3000'!$J$38,'expressionCol-H2O-M1-DC3000'!$J$41,'expressionCol-H2O-M1-DC3000'!$J$44)</c:f>
                <c:numCache>
                  <c:formatCode>General</c:formatCode>
                  <c:ptCount val="6"/>
                  <c:pt idx="0">
                    <c:v>0.1172302247716</c:v>
                  </c:pt>
                  <c:pt idx="1">
                    <c:v>0.279160662622002</c:v>
                  </c:pt>
                  <c:pt idx="2">
                    <c:v>0.114196701645304</c:v>
                  </c:pt>
                  <c:pt idx="3">
                    <c:v>0.116817131544231</c:v>
                  </c:pt>
                  <c:pt idx="4">
                    <c:v>0.0487705740061453</c:v>
                  </c:pt>
                  <c:pt idx="5">
                    <c:v>0.074230107698217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xVal>
            <c:numRef>
              <c:f>'expressionCol-H2O-M1-DC3000'!$L$3:$L$8</c:f>
              <c:numCache>
                <c:formatCode>General</c:formatCode>
                <c:ptCount val="6"/>
                <c:pt idx="0">
                  <c:v>0.0</c:v>
                </c:pt>
                <c:pt idx="1">
                  <c:v>4.0</c:v>
                </c:pt>
                <c:pt idx="2">
                  <c:v>8.0</c:v>
                </c:pt>
                <c:pt idx="3">
                  <c:v>12.0</c:v>
                </c:pt>
                <c:pt idx="4">
                  <c:v>24.0</c:v>
                </c:pt>
                <c:pt idx="5">
                  <c:v>48.0</c:v>
                </c:pt>
              </c:numCache>
            </c:numRef>
          </c:xVal>
          <c:yVal>
            <c:numRef>
              <c:f>'expressionCol-H2O-M1-DC3000'!$N$3:$N$8</c:f>
              <c:numCache>
                <c:formatCode>General</c:formatCode>
                <c:ptCount val="6"/>
                <c:pt idx="0">
                  <c:v>0.48358</c:v>
                </c:pt>
                <c:pt idx="1">
                  <c:v>0.982533333333333</c:v>
                </c:pt>
                <c:pt idx="2">
                  <c:v>0.7343</c:v>
                </c:pt>
                <c:pt idx="3">
                  <c:v>0.481933333333333</c:v>
                </c:pt>
                <c:pt idx="4">
                  <c:v>0.243833333333333</c:v>
                </c:pt>
                <c:pt idx="5">
                  <c:v>0.29326666666666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8039640"/>
        <c:axId val="-2124749096"/>
      </c:scatterChart>
      <c:valAx>
        <c:axId val="-21280396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-2124749096"/>
        <c:crosses val="autoZero"/>
        <c:crossBetween val="midCat"/>
      </c:valAx>
      <c:valAx>
        <c:axId val="-21247490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2128039640"/>
        <c:crosses val="autoZero"/>
        <c:crossBetween val="midCat"/>
      </c:valAx>
      <c:spPr>
        <a:ln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306109280540644"/>
          <c:y val="0.0932319531929473"/>
          <c:w val="0.270214977930716"/>
          <c:h val="0.120027080093825"/>
        </c:manualLayout>
      </c:layout>
      <c:overlay val="0"/>
      <c:txPr>
        <a:bodyPr/>
        <a:lstStyle/>
        <a:p>
          <a:pPr>
            <a:defRPr sz="800"/>
          </a:pPr>
          <a:endParaRPr lang="fr-FR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  <c:userShapes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05393438669416"/>
          <c:y val="0.0611823704844284"/>
          <c:w val="0.771266607233343"/>
          <c:h val="0.796671204254782"/>
        </c:manualLayout>
      </c:layout>
      <c:scatterChart>
        <c:scatterStyle val="lineMarker"/>
        <c:varyColors val="0"/>
        <c:ser>
          <c:idx val="0"/>
          <c:order val="0"/>
          <c:tx>
            <c:strRef>
              <c:f>'expressionCol-H2O-M1-DC3000'!$Q$2</c:f>
              <c:strCache>
                <c:ptCount val="1"/>
                <c:pt idx="0">
                  <c:v>H2O</c:v>
                </c:pt>
              </c:strCache>
            </c:strRef>
          </c:tx>
          <c:errBars>
            <c:errDir val="y"/>
            <c:errBarType val="plus"/>
            <c:errValType val="cust"/>
            <c:noEndCap val="0"/>
            <c:plus>
              <c:numRef>
                <c:f>('expressionCol-H2O-M1-DC3000'!$J$27,'expressionCol-H2O-M1-DC3000'!$J$9,'expressionCol-H2O-M1-DC3000'!$J$12,'expressionCol-H2O-M1-DC3000'!$J$15,'expressionCol-H2O-M1-DC3000'!$J$20)</c:f>
                <c:numCache>
                  <c:formatCode>General</c:formatCode>
                  <c:ptCount val="5"/>
                  <c:pt idx="0">
                    <c:v>0.1172302247716</c:v>
                  </c:pt>
                  <c:pt idx="1">
                    <c:v>0.3786</c:v>
                  </c:pt>
                  <c:pt idx="2">
                    <c:v>0.222387549611534</c:v>
                  </c:pt>
                  <c:pt idx="3">
                    <c:v>0.51687026311144</c:v>
                  </c:pt>
                  <c:pt idx="4">
                    <c:v>0.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xVal>
            <c:numRef>
              <c:f>'expressionCol-H2O-M1-DC3000'!$P$3:$P$7</c:f>
              <c:numCache>
                <c:formatCode>General</c:formatCode>
                <c:ptCount val="5"/>
                <c:pt idx="0">
                  <c:v>0.0</c:v>
                </c:pt>
                <c:pt idx="1">
                  <c:v>8.0</c:v>
                </c:pt>
                <c:pt idx="2">
                  <c:v>12.0</c:v>
                </c:pt>
                <c:pt idx="3">
                  <c:v>24.0</c:v>
                </c:pt>
                <c:pt idx="4">
                  <c:v>48.0</c:v>
                </c:pt>
              </c:numCache>
            </c:numRef>
          </c:xVal>
          <c:yVal>
            <c:numRef>
              <c:f>'expressionCol-H2O-M1-DC3000'!$Q$3:$Q$7</c:f>
              <c:numCache>
                <c:formatCode>General</c:formatCode>
                <c:ptCount val="5"/>
                <c:pt idx="0">
                  <c:v>0.48358</c:v>
                </c:pt>
                <c:pt idx="1">
                  <c:v>1.577933333333333</c:v>
                </c:pt>
                <c:pt idx="2">
                  <c:v>1.391666666666667</c:v>
                </c:pt>
                <c:pt idx="3">
                  <c:v>0.700433333333333</c:v>
                </c:pt>
                <c:pt idx="4">
                  <c:v>1.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expressionCol-H2O-M1-DC3000'!$R$2</c:f>
              <c:strCache>
                <c:ptCount val="1"/>
                <c:pt idx="0">
                  <c:v>DC3000</c:v>
                </c:pt>
              </c:strCache>
            </c:strRef>
          </c:tx>
          <c:spPr>
            <a:ln>
              <a:solidFill>
                <a:srgbClr val="92D050"/>
              </a:solidFill>
            </a:ln>
          </c:spPr>
          <c:marker>
            <c:spPr>
              <a:solidFill>
                <a:srgbClr val="92D050"/>
              </a:solidFill>
              <a:ln>
                <a:solidFill>
                  <a:srgbClr val="92D050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('expressionCol-H2O-M1-DC3000'!$J$27,'expressionCol-H2O-M1-DC3000'!$J$51,'expressionCol-H2O-M1-DC3000'!$J$54,'expressionCol-H2O-M1-DC3000'!$J$58,'expressionCol-H2O-M1-DC3000'!$J$61)</c:f>
                <c:numCache>
                  <c:formatCode>General</c:formatCode>
                  <c:ptCount val="5"/>
                  <c:pt idx="0">
                    <c:v>0.1172302247716</c:v>
                  </c:pt>
                  <c:pt idx="1">
                    <c:v>0.432475743700024</c:v>
                  </c:pt>
                  <c:pt idx="2">
                    <c:v>0.2272</c:v>
                  </c:pt>
                  <c:pt idx="3">
                    <c:v>0.38425</c:v>
                  </c:pt>
                  <c:pt idx="4">
                    <c:v>0.07919999999999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xVal>
            <c:numRef>
              <c:f>'expressionCol-H2O-M1-DC3000'!$P$3:$P$7</c:f>
              <c:numCache>
                <c:formatCode>General</c:formatCode>
                <c:ptCount val="5"/>
                <c:pt idx="0">
                  <c:v>0.0</c:v>
                </c:pt>
                <c:pt idx="1">
                  <c:v>8.0</c:v>
                </c:pt>
                <c:pt idx="2">
                  <c:v>12.0</c:v>
                </c:pt>
                <c:pt idx="3">
                  <c:v>24.0</c:v>
                </c:pt>
                <c:pt idx="4">
                  <c:v>48.0</c:v>
                </c:pt>
              </c:numCache>
            </c:numRef>
          </c:xVal>
          <c:yVal>
            <c:numRef>
              <c:f>'expressionCol-H2O-M1-DC3000'!$R$3:$R$7</c:f>
              <c:numCache>
                <c:formatCode>General</c:formatCode>
                <c:ptCount val="5"/>
                <c:pt idx="0">
                  <c:v>0.48358</c:v>
                </c:pt>
                <c:pt idx="1">
                  <c:v>1.050466666666667</c:v>
                </c:pt>
                <c:pt idx="2">
                  <c:v>0.6847</c:v>
                </c:pt>
                <c:pt idx="3">
                  <c:v>0.57985</c:v>
                </c:pt>
                <c:pt idx="4">
                  <c:v>0.564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18246232"/>
        <c:axId val="-2128204072"/>
      </c:scatterChart>
      <c:valAx>
        <c:axId val="2118246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-2128204072"/>
        <c:crosses val="autoZero"/>
        <c:crossBetween val="midCat"/>
      </c:valAx>
      <c:valAx>
        <c:axId val="-21282040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118246232"/>
        <c:crosses val="autoZero"/>
        <c:crossBetween val="midCat"/>
      </c:valAx>
      <c:spPr>
        <a:noFill/>
        <a:ln w="9525"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308905379077122"/>
          <c:y val="0.0831192572388262"/>
          <c:w val="0.250436265889156"/>
          <c:h val="0.15138038575041"/>
        </c:manualLayout>
      </c:layout>
      <c:overlay val="0"/>
      <c:txPr>
        <a:bodyPr/>
        <a:lstStyle/>
        <a:p>
          <a:pPr>
            <a:defRPr sz="800"/>
          </a:pPr>
          <a:endParaRPr lang="fr-FR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3182</cdr:x>
      <cdr:y>0.04368</cdr:y>
    </cdr:from>
    <cdr:to>
      <cdr:x>0.58182</cdr:x>
      <cdr:y>0.19519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303538" y="79556"/>
          <a:ext cx="1036236" cy="27593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fr-FR" sz="800" b="1" dirty="0" smtClean="0">
              <a:latin typeface="+mn-lt"/>
            </a:rPr>
            <a:t>AvrRpm1</a:t>
          </a:r>
          <a:endParaRPr lang="fr-FR" sz="800" b="1" dirty="0">
            <a:latin typeface="+mn-lt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0373</cdr:x>
      <cdr:y>0.03086</cdr:y>
    </cdr:from>
    <cdr:to>
      <cdr:x>0.50292</cdr:x>
      <cdr:y>0.18518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306244" y="55235"/>
          <a:ext cx="1178540" cy="27621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fr-FR" sz="800" b="1" dirty="0" smtClean="0">
              <a:latin typeface="+mn-lt"/>
            </a:rPr>
            <a:t>DC3000</a:t>
          </a:r>
          <a:endParaRPr lang="fr-FR" sz="800" b="1" dirty="0">
            <a:latin typeface="+mn-lt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DEE3A7-95C8-2A44-B663-0E9C408B4275}" type="datetimeFigureOut">
              <a:rPr lang="fr-FR" smtClean="0"/>
              <a:t>15/05/14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B8B5A1-AD2A-594D-B883-A449C28E5D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70248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D46D873-F6E0-7C4E-9000-29D23E5766B1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7485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FF372FA-F703-2D4D-BED0-8363C358E296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76655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886325" y="812800"/>
            <a:ext cx="1457325" cy="73152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514350" y="812800"/>
            <a:ext cx="4219575" cy="73152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AE35D58-10A4-0F4C-9C27-697ED48F0331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1758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B36C28-114E-E74F-90DD-DA0B9C5695B2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7306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2B2EB2-161F-1C44-91CF-8736C951E596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3704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51435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50520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6AD805-65E3-3A4B-88C9-CB66D331333D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142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C491BDE-44B7-AB42-9937-BE93FC32BB1A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47635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893A78-F04F-4D49-A99A-5A99B5808C54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8610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263ACE3-9FE3-5242-9733-89EBD7F92085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9348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46ACD3C-53EE-1642-AC32-E7D222C5BAC2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16008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FR" noProof="0" smtClean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4479E66-100C-2146-843E-9DD2FA25819E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4397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et modifiez le titr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ＭＳ Ｐゴシック" pitchFamily="112" charset="-128"/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ＭＳ Ｐゴシック" pitchFamily="112" charset="-128"/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E8DF59E0-D642-7645-9FA5-A8495344A6DE}" type="slidenum">
              <a:rPr lang="fr-FR"/>
              <a:pPr>
                <a:defRPr/>
              </a:pPr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112" charset="-128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112" charset="-128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112" charset="-128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112" charset="-128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112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112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112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pitchFamily="112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ZoneTexte 13"/>
          <p:cNvSpPr txBox="1"/>
          <p:nvPr/>
        </p:nvSpPr>
        <p:spPr>
          <a:xfrm>
            <a:off x="836712" y="6796697"/>
            <a:ext cx="53374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>
                <a:latin typeface="Arial" pitchFamily="34" charset="0"/>
                <a:cs typeface="Arial" pitchFamily="34" charset="0"/>
              </a:rPr>
              <a:t>Figure S1. </a:t>
            </a:r>
            <a:r>
              <a:rPr lang="en-GB" sz="1200" b="1" i="1" dirty="0" smtClean="0">
                <a:latin typeface="Arial" pitchFamily="34" charset="0"/>
                <a:cs typeface="Arial" pitchFamily="34" charset="0"/>
              </a:rPr>
              <a:t>LIF2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 expression in rosette leaves in response to </a:t>
            </a:r>
            <a:r>
              <a:rPr lang="en-GB" sz="1200" b="1" i="1" dirty="0" smtClean="0">
                <a:latin typeface="Arial" pitchFamily="34" charset="0"/>
                <a:cs typeface="Arial" pitchFamily="34" charset="0"/>
              </a:rPr>
              <a:t>P. </a:t>
            </a:r>
            <a:r>
              <a:rPr lang="en-GB" sz="1200" b="1" i="1" dirty="0" smtClean="0">
                <a:latin typeface="Arial"/>
                <a:cs typeface="Arial"/>
              </a:rPr>
              <a:t>syringae </a:t>
            </a:r>
            <a:r>
              <a:rPr lang="en-GB" sz="1200" b="1" dirty="0" smtClean="0">
                <a:latin typeface="Arial"/>
                <a:cs typeface="Arial"/>
              </a:rPr>
              <a:t>DC3000</a:t>
            </a:r>
            <a:r>
              <a:rPr lang="en-GB" sz="1200" b="1" i="1" dirty="0" smtClean="0">
                <a:latin typeface="Arial"/>
                <a:cs typeface="Arial"/>
              </a:rPr>
              <a:t> </a:t>
            </a:r>
            <a:r>
              <a:rPr lang="en-GB" sz="1200" b="1" dirty="0" smtClean="0">
                <a:latin typeface="Arial"/>
                <a:cs typeface="Arial"/>
              </a:rPr>
              <a:t>(A) and DC3000 </a:t>
            </a:r>
            <a:r>
              <a:rPr lang="en-GB" sz="1200" b="1" i="1" dirty="0" smtClean="0">
                <a:latin typeface="Arial"/>
                <a:cs typeface="Arial"/>
              </a:rPr>
              <a:t>avrRpm1 </a:t>
            </a:r>
            <a:r>
              <a:rPr lang="en-GB" sz="1200" b="1" dirty="0" smtClean="0">
                <a:latin typeface="Arial"/>
                <a:cs typeface="Arial"/>
              </a:rPr>
              <a:t>(B) inoculations.</a:t>
            </a:r>
          </a:p>
          <a:p>
            <a:pPr algn="just"/>
            <a:r>
              <a:rPr lang="en-GB" sz="1200" dirty="0" err="1">
                <a:latin typeface="Arial" pitchFamily="34" charset="0"/>
                <a:cs typeface="Arial" pitchFamily="34" charset="0"/>
              </a:rPr>
              <a:t>h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pi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, hour post-inoculation.</a:t>
            </a:r>
          </a:p>
        </p:txBody>
      </p:sp>
      <p:grpSp>
        <p:nvGrpSpPr>
          <p:cNvPr id="5" name="Grouper 4"/>
          <p:cNvGrpSpPr/>
          <p:nvPr/>
        </p:nvGrpSpPr>
        <p:grpSpPr>
          <a:xfrm>
            <a:off x="1874415" y="1403648"/>
            <a:ext cx="3210769" cy="4346321"/>
            <a:chOff x="650280" y="1403648"/>
            <a:chExt cx="3210769" cy="4346321"/>
          </a:xfrm>
        </p:grpSpPr>
        <p:graphicFrame>
          <p:nvGraphicFramePr>
            <p:cNvPr id="4" name="Graphique 3"/>
            <p:cNvGraphicFramePr/>
            <p:nvPr>
              <p:extLst>
                <p:ext uri="{D42A27DB-BD31-4B8C-83A1-F6EECF244321}">
                  <p14:modId xmlns:p14="http://schemas.microsoft.com/office/powerpoint/2010/main" val="1596079926"/>
                </p:ext>
              </p:extLst>
            </p:nvPr>
          </p:nvGraphicFramePr>
          <p:xfrm>
            <a:off x="840905" y="3907036"/>
            <a:ext cx="2952328" cy="18212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3" name="Graphique 12"/>
            <p:cNvGraphicFramePr/>
            <p:nvPr>
              <p:extLst>
                <p:ext uri="{D42A27DB-BD31-4B8C-83A1-F6EECF244321}">
                  <p14:modId xmlns:p14="http://schemas.microsoft.com/office/powerpoint/2010/main" val="3445140554"/>
                </p:ext>
              </p:extLst>
            </p:nvPr>
          </p:nvGraphicFramePr>
          <p:xfrm>
            <a:off x="908721" y="1835696"/>
            <a:ext cx="2952328" cy="17898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5" name="ZoneTexte 14"/>
            <p:cNvSpPr txBox="1"/>
            <p:nvPr/>
          </p:nvSpPr>
          <p:spPr>
            <a:xfrm rot="16200000">
              <a:off x="-219332" y="2273260"/>
              <a:ext cx="20162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fr-FR" sz="1200" dirty="0" smtClean="0"/>
                <a:t>Relative expression</a:t>
              </a:r>
              <a:endParaRPr lang="fr-FR" sz="1200" dirty="0"/>
            </a:p>
          </p:txBody>
        </p:sp>
        <p:sp>
          <p:nvSpPr>
            <p:cNvPr id="2" name="ZoneTexte 1"/>
            <p:cNvSpPr txBox="1"/>
            <p:nvPr/>
          </p:nvSpPr>
          <p:spPr>
            <a:xfrm flipH="1">
              <a:off x="2219660" y="5519137"/>
              <a:ext cx="10801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 err="1"/>
                <a:t>h</a:t>
              </a:r>
              <a:r>
                <a:rPr lang="en-GB" sz="900" b="1" dirty="0" err="1" smtClean="0"/>
                <a:t>pi</a:t>
              </a:r>
              <a:endParaRPr lang="en-GB" sz="900" b="1" dirty="0"/>
            </a:p>
          </p:txBody>
        </p:sp>
        <p:sp>
          <p:nvSpPr>
            <p:cNvPr id="17" name="ZoneTexte 16"/>
            <p:cNvSpPr txBox="1"/>
            <p:nvPr/>
          </p:nvSpPr>
          <p:spPr>
            <a:xfrm flipH="1">
              <a:off x="2183656" y="3494405"/>
              <a:ext cx="11521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 err="1"/>
                <a:t>h</a:t>
              </a:r>
              <a:r>
                <a:rPr lang="en-GB" sz="900" b="1" dirty="0" err="1" smtClean="0"/>
                <a:t>pi</a:t>
              </a:r>
              <a:endParaRPr lang="en-GB" sz="900" b="1" dirty="0"/>
            </a:p>
          </p:txBody>
        </p:sp>
        <p:sp>
          <p:nvSpPr>
            <p:cNvPr id="12" name="ZoneTexte 11"/>
            <p:cNvSpPr txBox="1"/>
            <p:nvPr/>
          </p:nvSpPr>
          <p:spPr>
            <a:xfrm rot="16200000">
              <a:off x="-219332" y="4289485"/>
              <a:ext cx="20162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fr-FR" sz="1200" dirty="0" smtClean="0"/>
                <a:t>Relative expression</a:t>
              </a:r>
              <a:endParaRPr lang="fr-FR" sz="1200" dirty="0"/>
            </a:p>
          </p:txBody>
        </p:sp>
      </p:grpSp>
      <p:sp>
        <p:nvSpPr>
          <p:cNvPr id="3" name="ZoneTexte 2"/>
          <p:cNvSpPr txBox="1"/>
          <p:nvPr/>
        </p:nvSpPr>
        <p:spPr>
          <a:xfrm>
            <a:off x="3293451" y="1954635"/>
            <a:ext cx="57606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/>
              <a:t>H</a:t>
            </a:r>
            <a:r>
              <a:rPr lang="en-GB" sz="800" baseline="-25000" dirty="0" smtClean="0"/>
              <a:t>2</a:t>
            </a:r>
            <a:r>
              <a:rPr lang="en-GB" sz="800" dirty="0" smtClean="0"/>
              <a:t>O</a:t>
            </a:r>
          </a:p>
          <a:p>
            <a:r>
              <a:rPr lang="en-GB" sz="800" dirty="0" smtClean="0"/>
              <a:t>DC3000</a:t>
            </a:r>
            <a:endParaRPr lang="en-GB" sz="800" dirty="0"/>
          </a:p>
        </p:txBody>
      </p:sp>
      <p:sp>
        <p:nvSpPr>
          <p:cNvPr id="11" name="ZoneTexte 10"/>
          <p:cNvSpPr txBox="1"/>
          <p:nvPr/>
        </p:nvSpPr>
        <p:spPr>
          <a:xfrm>
            <a:off x="3323422" y="4017101"/>
            <a:ext cx="461432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/>
              <a:t>H</a:t>
            </a:r>
            <a:r>
              <a:rPr lang="en-GB" sz="800" baseline="-25000" dirty="0" smtClean="0"/>
              <a:t>2</a:t>
            </a:r>
            <a:r>
              <a:rPr lang="en-GB" sz="800" dirty="0" smtClean="0"/>
              <a:t>O</a:t>
            </a:r>
          </a:p>
          <a:p>
            <a:r>
              <a:rPr lang="en-GB" sz="800" dirty="0" smtClean="0"/>
              <a:t>Rpm1</a:t>
            </a:r>
            <a:endParaRPr lang="en-GB" sz="800" dirty="0"/>
          </a:p>
        </p:txBody>
      </p:sp>
      <p:sp>
        <p:nvSpPr>
          <p:cNvPr id="16" name="ZoneTexte 1"/>
          <p:cNvSpPr txBox="1">
            <a:spLocks noChangeArrowheads="1"/>
          </p:cNvSpPr>
          <p:nvPr/>
        </p:nvSpPr>
        <p:spPr bwMode="auto">
          <a:xfrm>
            <a:off x="1844824" y="1547664"/>
            <a:ext cx="3257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GB" sz="1400" b="1" dirty="0" smtClean="0">
                <a:latin typeface="Helvetica" charset="0"/>
                <a:cs typeface="Helvetica" charset="0"/>
              </a:rPr>
              <a:t>A</a:t>
            </a:r>
            <a:endParaRPr lang="en-GB" sz="1400" b="1" dirty="0">
              <a:latin typeface="Helvetica" charset="0"/>
              <a:cs typeface="Helvetica" charset="0"/>
            </a:endParaRPr>
          </a:p>
        </p:txBody>
      </p:sp>
      <p:sp>
        <p:nvSpPr>
          <p:cNvPr id="18" name="ZoneTexte 1"/>
          <p:cNvSpPr txBox="1">
            <a:spLocks noChangeArrowheads="1"/>
          </p:cNvSpPr>
          <p:nvPr/>
        </p:nvSpPr>
        <p:spPr bwMode="auto">
          <a:xfrm>
            <a:off x="1844824" y="3635896"/>
            <a:ext cx="31432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GB" sz="1400" b="1" dirty="0">
                <a:latin typeface="Helvetica" charset="0"/>
                <a:cs typeface="Helvetica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659609189"/>
      </p:ext>
    </p:extLst>
  </p:cSld>
  <p:clrMapOvr>
    <a:masterClrMapping/>
  </p:clrMapOvr>
</p:sld>
</file>

<file path=ppt/theme/theme1.xml><?xml version="1.0" encoding="utf-8"?>
<a:theme xmlns:a="http://schemas.openxmlformats.org/drawingml/2006/main" name="Nouvelle présentation">
  <a:themeElements>
    <a:clrScheme name="Nouvelle présentatio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Nouvelle présentation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fr-FR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112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fr-FR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112" charset="-128"/>
          </a:defRPr>
        </a:defPPr>
      </a:lstStyle>
    </a:lnDef>
  </a:objectDefaults>
  <a:extraClrSchemeLst>
    <a:extraClrScheme>
      <a:clrScheme name="Nouvelle présentatio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Nouvelle présentatio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Nouvelle présentatio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Nouvelle présentatio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Nouvelle présentatio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Nouvelle présentatio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Nouvelle présentatio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Nouvelle présentatio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Nouvelle présentatio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Nouvelle présentatio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Nouvelle présentatio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Nouvelle présentatio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Nouvelle présentatio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Nouvelle présentation">
    <a:majorFont>
      <a:latin typeface="Arial"/>
      <a:ea typeface="ＭＳ Ｐゴシック"/>
      <a:cs typeface=""/>
    </a:majorFont>
    <a:minorFont>
      <a:latin typeface="Arial"/>
      <a:ea typeface="ＭＳ Ｐゴシック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Nouvelle présentatio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Nouvelle présentation">
    <a:majorFont>
      <a:latin typeface="Arial"/>
      <a:ea typeface="ＭＳ Ｐゴシック"/>
      <a:cs typeface=""/>
    </a:majorFont>
    <a:minorFont>
      <a:latin typeface="Arial"/>
      <a:ea typeface="ＭＳ Ｐゴシック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691</TotalTime>
  <Words>47</Words>
  <Application>Microsoft Macintosh PowerPoint</Application>
  <PresentationFormat>Présentation à l'écran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Nouvelle présentation</vt:lpstr>
      <vt:lpstr>Présentation PowerPoint</vt:lpstr>
    </vt:vector>
  </TitlesOfParts>
  <Company>IN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lémentine Le ROUX</dc:creator>
  <cp:lastModifiedBy>Valérie inra</cp:lastModifiedBy>
  <cp:revision>923</cp:revision>
  <cp:lastPrinted>2013-12-11T18:25:27Z</cp:lastPrinted>
  <dcterms:created xsi:type="dcterms:W3CDTF">2012-10-09T11:25:49Z</dcterms:created>
  <dcterms:modified xsi:type="dcterms:W3CDTF">2014-05-15T17:07:13Z</dcterms:modified>
</cp:coreProperties>
</file>